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94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39" roundtripDataSignature="AMtx7mhfEcfid27dPhuHaO3f3rJ0JKUpJQ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ylvain vrignon" initials="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C11DE"/>
    <a:srgbClr val="06086A"/>
    <a:srgbClr val="383C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3AFCCA97-0C20-473B-895E-A2B30A317067}">
  <a:tblStyle styleId="{3AFCCA97-0C20-473B-895E-A2B30A317067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9E0BD6F8-2214-45E8-847D-E3C46BF50E33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V>
        </a:tcBdr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30" d="100"/>
          <a:sy n="130" d="100"/>
        </p:scale>
        <p:origin x="8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9" Type="http://customschemas.google.com/relationships/presentationmetadata" Target="metadata"/><Relationship Id="rId3" Type="http://schemas.openxmlformats.org/officeDocument/2006/relationships/notesMaster" Target="notesMasters/notesMaster1.xml"/><Relationship Id="rId42" Type="http://schemas.openxmlformats.org/officeDocument/2006/relationships/viewProps" Target="viewProps.xml"/><Relationship Id="rId2" Type="http://schemas.openxmlformats.org/officeDocument/2006/relationships/slide" Target="slides/slide1.xml"/><Relationship Id="rId41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40" Type="http://schemas.openxmlformats.org/officeDocument/2006/relationships/commentAuthors" Target="commentAuthors.xml"/><Relationship Id="rId44" Type="http://schemas.openxmlformats.org/officeDocument/2006/relationships/tableStyles" Target="tableStyles.xml"/><Relationship Id="rId43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4" name="Google Shape;24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5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6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6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6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8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8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8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9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9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0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1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1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5FBC4687-7A75-4798-BB66-DBCB9E74AE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8247542"/>
              </p:ext>
            </p:extLst>
          </p:nvPr>
        </p:nvGraphicFramePr>
        <p:xfrm>
          <a:off x="0" y="0"/>
          <a:ext cx="5694162" cy="6851946"/>
        </p:xfrm>
        <a:graphic>
          <a:graphicData uri="http://schemas.openxmlformats.org/drawingml/2006/table">
            <a:tbl>
              <a:tblPr>
                <a:tableStyleId>{3AFCCA97-0C20-473B-895E-A2B30A317067}</a:tableStyleId>
              </a:tblPr>
              <a:tblGrid>
                <a:gridCol w="665825">
                  <a:extLst>
                    <a:ext uri="{9D8B030D-6E8A-4147-A177-3AD203B41FA5}">
                      <a16:colId xmlns:a16="http://schemas.microsoft.com/office/drawing/2014/main" val="4151754295"/>
                    </a:ext>
                  </a:extLst>
                </a:gridCol>
                <a:gridCol w="2645546">
                  <a:extLst>
                    <a:ext uri="{9D8B030D-6E8A-4147-A177-3AD203B41FA5}">
                      <a16:colId xmlns:a16="http://schemas.microsoft.com/office/drawing/2014/main" val="100451934"/>
                    </a:ext>
                  </a:extLst>
                </a:gridCol>
                <a:gridCol w="524405">
                  <a:extLst>
                    <a:ext uri="{9D8B030D-6E8A-4147-A177-3AD203B41FA5}">
                      <a16:colId xmlns:a16="http://schemas.microsoft.com/office/drawing/2014/main" val="3602005778"/>
                    </a:ext>
                  </a:extLst>
                </a:gridCol>
                <a:gridCol w="649978">
                  <a:extLst>
                    <a:ext uri="{9D8B030D-6E8A-4147-A177-3AD203B41FA5}">
                      <a16:colId xmlns:a16="http://schemas.microsoft.com/office/drawing/2014/main" val="2444496640"/>
                    </a:ext>
                  </a:extLst>
                </a:gridCol>
                <a:gridCol w="622513">
                  <a:extLst>
                    <a:ext uri="{9D8B030D-6E8A-4147-A177-3AD203B41FA5}">
                      <a16:colId xmlns:a16="http://schemas.microsoft.com/office/drawing/2014/main" val="646513463"/>
                    </a:ext>
                  </a:extLst>
                </a:gridCol>
                <a:gridCol w="585895">
                  <a:extLst>
                    <a:ext uri="{9D8B030D-6E8A-4147-A177-3AD203B41FA5}">
                      <a16:colId xmlns:a16="http://schemas.microsoft.com/office/drawing/2014/main" val="674843674"/>
                    </a:ext>
                  </a:extLst>
                </a:gridCol>
              </a:tblGrid>
              <a:tr h="108000">
                <a:tc rowSpan="2" gridSpan="2"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 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 rowSpan="2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) </a:t>
                      </a: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ibutions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) cos²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6597278"/>
                  </a:ext>
                </a:extLst>
              </a:tr>
              <a:tr h="108000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m.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m.4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m.2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m.4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224392160"/>
                  </a:ext>
                </a:extLst>
              </a:tr>
              <a:tr h="108000">
                <a:tc rowSpan="27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tative 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nk</a:t>
                      </a:r>
                      <a:r>
                        <a:rPr lang="en-US" sz="7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</a:t>
                      </a: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ch content (mg 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 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415090047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nk nitrogen content 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947809555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il organic matter (%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600950221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 (water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630344115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 (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l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2103004641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C (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q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100g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2057448639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il active calcium 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628813916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ailable phosphorus (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oret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od. 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m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885459456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il potassium available (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q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00g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4215257056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il calcium available (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q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00g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877731715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il magnesium available (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q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00g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674785407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il sodium 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ailable (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q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00g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947883512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il total nitrogen (%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687046064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clay (%) in soil (0-30cm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483331600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silt (%) in soil (0-30cm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312516121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sand (%) in soil (0-30cm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522190913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buds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456880961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r humidity (%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090256372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n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ily rainfalls near flowering (mm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4061230545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mulative rainfalls near flowering (mm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899085705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temperature one month after fertilization (°C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53690113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n  temperature one month after fertilization (°C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913044243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imum air humidity one month after fertilization (°C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2644157799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air humidity one month after fertilization (°C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2884391805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mulative global radiation one month after fertilization (°C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4086351482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mulative rainfalls one month after fertilization (°C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156666936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mulative potential evaporation one month after fertilization (°C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2659304071"/>
                  </a:ext>
                </a:extLst>
              </a:tr>
              <a:tr h="108000">
                <a:tc rowSpan="4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litative 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va bean cover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5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9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58053304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pontaneous cover 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490745093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lot 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page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2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1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980831519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uvigno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lanc </a:t>
                      </a: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page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614504773"/>
                  </a:ext>
                </a:extLst>
              </a:tr>
              <a:tr h="108000">
                <a:tc rowSpan="5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 </a:t>
                      </a: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 (indicators)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_LNC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 rowSpan="5"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>
                    <a:solidFill>
                      <a:schemeClr val="tx1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2441158073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_SPAD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507347978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_YAN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919912792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_SMN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949693921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_YIELD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028141007"/>
                  </a:ext>
                </a:extLst>
              </a:tr>
              <a:tr h="108000">
                <a:tc rowSpan="15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ividuals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2 1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8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526598475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2 2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4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725054655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2 3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201454133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2 1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10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63541461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2 2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9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603718342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2 3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1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046406661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2 1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1237331039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2 2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2405915632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2 3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2917492943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 2 1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4103213325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 2 2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2730190744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 2 3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3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4166278459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 2 1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1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685139263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 2 2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5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3069283986"/>
                  </a:ext>
                </a:extLst>
              </a:tr>
              <a:tr h="108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 2 3</a:t>
                      </a:r>
                      <a:endParaRPr lang="fr-FR" sz="7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fr-FR" sz="7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301" marR="11301" marT="11301" marB="11301"/>
                </a:tc>
                <a:extLst>
                  <a:ext uri="{0D108BD9-81ED-4DB2-BD59-A6C34878D82A}">
                    <a16:rowId xmlns:a16="http://schemas.microsoft.com/office/drawing/2014/main" val="753491064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52A056E6-5987-4CF7-8A94-0EF5646B0DFA}"/>
              </a:ext>
            </a:extLst>
          </p:cNvPr>
          <p:cNvSpPr txBox="1"/>
          <p:nvPr/>
        </p:nvSpPr>
        <p:spPr>
          <a:xfrm>
            <a:off x="6047235" y="6410084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Table S2</a:t>
            </a:r>
          </a:p>
        </p:txBody>
      </p:sp>
    </p:spTree>
    <p:extLst>
      <p:ext uri="{BB962C8B-B14F-4D97-AF65-F5344CB8AC3E}">
        <p14:creationId xmlns:p14="http://schemas.microsoft.com/office/powerpoint/2010/main" val="381749637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3</TotalTime>
  <Words>464</Words>
  <Application>Microsoft Office PowerPoint</Application>
  <PresentationFormat>Grand écran</PresentationFormat>
  <Paragraphs>25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rignons</dc:creator>
  <cp:lastModifiedBy>Anne PELLEGRINO</cp:lastModifiedBy>
  <cp:revision>42</cp:revision>
  <dcterms:created xsi:type="dcterms:W3CDTF">2021-06-01T10:10:20Z</dcterms:created>
  <dcterms:modified xsi:type="dcterms:W3CDTF">2024-09-27T12:22:12Z</dcterms:modified>
</cp:coreProperties>
</file>